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59" autoAdjust="0"/>
    <p:restoredTop sz="94660"/>
  </p:normalViewPr>
  <p:slideViewPr>
    <p:cSldViewPr snapToGrid="0">
      <p:cViewPr varScale="1">
        <p:scale>
          <a:sx n="89" d="100"/>
          <a:sy n="89" d="100"/>
        </p:scale>
        <p:origin x="8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578A04-95C5-4478-97DD-DE96BB16C05F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FD1E38-96AA-42EA-938E-B9F05C012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327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55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736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647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32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033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460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056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97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10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646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269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138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/>
          </p:nvPr>
        </p:nvGraphicFramePr>
        <p:xfrm>
          <a:off x="2124939" y="2179404"/>
          <a:ext cx="5808523" cy="2819513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092686">
                  <a:extLst>
                    <a:ext uri="{9D8B030D-6E8A-4147-A177-3AD203B41FA5}">
                      <a16:colId xmlns:a16="http://schemas.microsoft.com/office/drawing/2014/main" val="19305998"/>
                    </a:ext>
                  </a:extLst>
                </a:gridCol>
                <a:gridCol w="4715837">
                  <a:extLst>
                    <a:ext uri="{9D8B030D-6E8A-4147-A177-3AD203B41FA5}">
                      <a16:colId xmlns:a16="http://schemas.microsoft.com/office/drawing/2014/main" val="1975627607"/>
                    </a:ext>
                  </a:extLst>
                </a:gridCol>
              </a:tblGrid>
              <a:tr h="29718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static Site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2982854"/>
                  </a:ext>
                </a:extLst>
              </a:tr>
              <a:tr h="50682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NBSGW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o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 (60%), bone marrow (70%), eye (10%), , lungs (40%), heart (20%), eye (10%), sternum (10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05298289"/>
                  </a:ext>
                </a:extLst>
              </a:tr>
              <a:tr h="6749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NBSGW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 (40%), bone marrow (30%), liver (40%) , lungs (50%), heart (20%), sternum (10%), urinary system + adrenal glands (40%), gastrointestinal system (20%), reproductive tract (30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202064242"/>
                  </a:ext>
                </a:extLst>
              </a:tr>
              <a:tr h="47645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SGW </a:t>
                      </a:r>
                      <a:r>
                        <a:rPr lang="en-US" sz="12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o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 (50%), bone marrow (25%), lungs (25%), eye (63%), sternum (38%), olfactory bulbs (13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084618809"/>
                  </a:ext>
                </a:extLst>
              </a:tr>
              <a:tr h="86407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BGW </a:t>
                      </a:r>
                      <a:endParaRPr lang="en-US" sz="1200" u="none" strike="noStrike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 fontAlgn="b"/>
                      <a:r>
                        <a:rPr lang="en-US" sz="12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 (30%), liver (20%), eye (20%), bone marrow (20%), lungs (30%), heart (20%), eye (20%), sternum (70%), urinary system + adrenal glands (10%), gastrointestinal system (30%), reproductive tract (20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7929503"/>
                  </a:ext>
                </a:extLst>
              </a:tr>
            </a:tbl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ECBC5D88-7DFC-9F51-ABD6-52EAE0D2A0E4}"/>
              </a:ext>
            </a:extLst>
          </p:cNvPr>
          <p:cNvSpPr txBox="1">
            <a:spLocks/>
          </p:cNvSpPr>
          <p:nvPr/>
        </p:nvSpPr>
        <p:spPr>
          <a:xfrm>
            <a:off x="2124939" y="1844006"/>
            <a:ext cx="3666908" cy="397042"/>
          </a:xfrm>
          <a:prstGeom prst="rect">
            <a:avLst/>
          </a:prstGeom>
        </p:spPr>
        <p:txBody>
          <a:bodyPr vert="horz" lIns="75438" tIns="37719" rIns="75438" bIns="37719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2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Macrometastases</a:t>
            </a:r>
            <a:r>
              <a:rPr kumimoji="0" lang="en-US" sz="132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in </a:t>
            </a:r>
            <a:r>
              <a:rPr kumimoji="0" lang="en-US" sz="132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2</a:t>
            </a:r>
            <a:r>
              <a:rPr kumimoji="0" lang="en-US" sz="1320" b="1" i="0" u="none" strike="noStrike" kern="1200" cap="none" spc="0" normalizeH="0" baseline="3000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nd</a:t>
            </a:r>
            <a:r>
              <a:rPr kumimoji="0" lang="en-US" sz="132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generation </a:t>
            </a:r>
            <a:r>
              <a:rPr kumimoji="0" lang="en-US" sz="132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mice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407057" y="608222"/>
            <a:ext cx="32442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Table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3</a:t>
            </a:r>
          </a:p>
        </p:txBody>
      </p:sp>
    </p:spTree>
    <p:extLst>
      <p:ext uri="{BB962C8B-B14F-4D97-AF65-F5344CB8AC3E}">
        <p14:creationId xmlns:p14="http://schemas.microsoft.com/office/powerpoint/2010/main" val="29707553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</TotalTime>
  <Words>169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ana N Montoya</dc:creator>
  <cp:lastModifiedBy>Kyana N Montoya</cp:lastModifiedBy>
  <cp:revision>16</cp:revision>
  <dcterms:created xsi:type="dcterms:W3CDTF">2024-11-19T17:14:58Z</dcterms:created>
  <dcterms:modified xsi:type="dcterms:W3CDTF">2024-11-19T17:43:08Z</dcterms:modified>
</cp:coreProperties>
</file>